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534" r:id="rId2"/>
    <p:sldId id="54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" id="{039516B5-A7B1-45C8-8C63-21EEE43692FD}">
          <p14:sldIdLst>
            <p14:sldId id="534"/>
            <p14:sldId id="54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AED6A4-2AA8-4004-A1BF-922E31F91CE3}" v="1" dt="2023-05-19T15:27:05.56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635" autoAdjust="0"/>
    <p:restoredTop sz="95683" autoAdjust="0"/>
  </p:normalViewPr>
  <p:slideViewPr>
    <p:cSldViewPr snapToGrid="0">
      <p:cViewPr>
        <p:scale>
          <a:sx n="75" d="100"/>
          <a:sy n="75" d="100"/>
        </p:scale>
        <p:origin x="2430" y="10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ola, Hannah" userId="6278648c-fe43-450a-843a-1b5ce898bc2d" providerId="ADAL" clId="{7AAED6A4-2AA8-4004-A1BF-922E31F91CE3}"/>
    <pc:docChg chg="custSel delSld modSld delSection modSection">
      <pc:chgData name="Viola, Hannah" userId="6278648c-fe43-450a-843a-1b5ce898bc2d" providerId="ADAL" clId="{7AAED6A4-2AA8-4004-A1BF-922E31F91CE3}" dt="2023-05-19T15:27:09.289" v="6" actId="2696"/>
      <pc:docMkLst>
        <pc:docMk/>
      </pc:docMkLst>
      <pc:sldChg chg="del">
        <pc:chgData name="Viola, Hannah" userId="6278648c-fe43-450a-843a-1b5ce898bc2d" providerId="ADAL" clId="{7AAED6A4-2AA8-4004-A1BF-922E31F91CE3}" dt="2023-05-17T15:16:09.743" v="0" actId="47"/>
        <pc:sldMkLst>
          <pc:docMk/>
          <pc:sldMk cId="3433354613" sldId="411"/>
        </pc:sldMkLst>
      </pc:sldChg>
      <pc:sldChg chg="del">
        <pc:chgData name="Viola, Hannah" userId="6278648c-fe43-450a-843a-1b5ce898bc2d" providerId="ADAL" clId="{7AAED6A4-2AA8-4004-A1BF-922E31F91CE3}" dt="2023-05-17T15:16:09.743" v="0" actId="47"/>
        <pc:sldMkLst>
          <pc:docMk/>
          <pc:sldMk cId="3069317769" sldId="430"/>
        </pc:sldMkLst>
      </pc:sldChg>
      <pc:sldChg chg="del">
        <pc:chgData name="Viola, Hannah" userId="6278648c-fe43-450a-843a-1b5ce898bc2d" providerId="ADAL" clId="{7AAED6A4-2AA8-4004-A1BF-922E31F91CE3}" dt="2023-05-17T15:16:09.743" v="0" actId="47"/>
        <pc:sldMkLst>
          <pc:docMk/>
          <pc:sldMk cId="2500756939" sldId="533"/>
        </pc:sldMkLst>
      </pc:sldChg>
      <pc:sldChg chg="modSp mod">
        <pc:chgData name="Viola, Hannah" userId="6278648c-fe43-450a-843a-1b5ce898bc2d" providerId="ADAL" clId="{7AAED6A4-2AA8-4004-A1BF-922E31F91CE3}" dt="2023-05-19T15:26:56.320" v="3" actId="20577"/>
        <pc:sldMkLst>
          <pc:docMk/>
          <pc:sldMk cId="2653070031" sldId="534"/>
        </pc:sldMkLst>
        <pc:spChg chg="mod">
          <ac:chgData name="Viola, Hannah" userId="6278648c-fe43-450a-843a-1b5ce898bc2d" providerId="ADAL" clId="{7AAED6A4-2AA8-4004-A1BF-922E31F91CE3}" dt="2023-05-19T15:26:56.320" v="3" actId="20577"/>
          <ac:spMkLst>
            <pc:docMk/>
            <pc:sldMk cId="2653070031" sldId="534"/>
            <ac:spMk id="3" creationId="{6086FA55-D388-8813-FCB8-045648EEA27A}"/>
          </ac:spMkLst>
        </pc:spChg>
      </pc:sldChg>
      <pc:sldChg chg="del">
        <pc:chgData name="Viola, Hannah" userId="6278648c-fe43-450a-843a-1b5ce898bc2d" providerId="ADAL" clId="{7AAED6A4-2AA8-4004-A1BF-922E31F91CE3}" dt="2023-05-17T15:16:09.743" v="0" actId="47"/>
        <pc:sldMkLst>
          <pc:docMk/>
          <pc:sldMk cId="2884553609" sldId="535"/>
        </pc:sldMkLst>
      </pc:sldChg>
      <pc:sldChg chg="delSp del mod">
        <pc:chgData name="Viola, Hannah" userId="6278648c-fe43-450a-843a-1b5ce898bc2d" providerId="ADAL" clId="{7AAED6A4-2AA8-4004-A1BF-922E31F91CE3}" dt="2023-05-19T15:27:09.289" v="6" actId="2696"/>
        <pc:sldMkLst>
          <pc:docMk/>
          <pc:sldMk cId="2430786305" sldId="540"/>
        </pc:sldMkLst>
        <pc:spChg chg="del">
          <ac:chgData name="Viola, Hannah" userId="6278648c-fe43-450a-843a-1b5ce898bc2d" providerId="ADAL" clId="{7AAED6A4-2AA8-4004-A1BF-922E31F91CE3}" dt="2023-05-19T15:27:05.560" v="5" actId="478"/>
          <ac:spMkLst>
            <pc:docMk/>
            <pc:sldMk cId="2430786305" sldId="540"/>
            <ac:spMk id="3" creationId="{805FEA85-8973-6E41-C833-A8584160E8AF}"/>
          </ac:spMkLst>
        </pc:spChg>
        <pc:graphicFrameChg chg="del">
          <ac:chgData name="Viola, Hannah" userId="6278648c-fe43-450a-843a-1b5ce898bc2d" providerId="ADAL" clId="{7AAED6A4-2AA8-4004-A1BF-922E31F91CE3}" dt="2023-05-19T15:27:02.976" v="4" actId="478"/>
          <ac:graphicFrameMkLst>
            <pc:docMk/>
            <pc:sldMk cId="2430786305" sldId="540"/>
            <ac:graphicFrameMk id="2" creationId="{10CC5417-C683-A58E-BED7-A4D3B8B543F6}"/>
          </ac:graphicFrameMkLst>
        </pc:graphicFrameChg>
      </pc:sldChg>
      <pc:sldChg chg="del">
        <pc:chgData name="Viola, Hannah" userId="6278648c-fe43-450a-843a-1b5ce898bc2d" providerId="ADAL" clId="{7AAED6A4-2AA8-4004-A1BF-922E31F91CE3}" dt="2023-05-17T15:16:09.743" v="0" actId="47"/>
        <pc:sldMkLst>
          <pc:docMk/>
          <pc:sldMk cId="972135291" sldId="54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837F07-6589-403E-B2F1-73D08DC2AEA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0BABA7-B515-426D-B19D-1D75F6837A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07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0FD11-6408-4558-8870-F85FA424D4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21688F-1C86-419B-B505-EDE318CC5B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292FB9-DCA0-4791-AE78-A47CFBDA2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4A0E6-35C2-4E14-A51D-247A1B2D8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B59111-ACFD-4234-B423-68CE9A3B4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823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7BEF3C-795E-47DA-B800-4B840C917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942EAE-6532-4222-A5A3-86B233A74B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B447C-7CFF-4101-95D2-1FF802145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C26D07-9892-43A3-8166-B22724298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EFB210-0DA1-4E33-8FED-C7E25FEA1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244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75E7A7-2C72-4667-B359-34F34F0DAC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177703-88B4-4024-B8A6-25D54F5690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17E23-4C6E-4389-ACE4-E04E728D9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A92A9F-C3A5-4FA5-87AB-23AE90889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F64CBE-51DA-4C4B-B7DD-7385E4C3F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523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E3596-1CFE-40ED-B0E8-E309428AE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AD1A60-63D5-4925-813F-7463E41BB4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DC837A-F7D8-4F65-8A7A-B4D4FE6EA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A9A5F6-0653-47F8-999F-A4F536A1C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165C7-BF12-463E-AC69-F48DB025B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97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DE8E4-30AF-4E44-809E-B642F6EF82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A2CCCE-7E60-4D7B-9E2B-57F4B70660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42EA8-157E-4902-A4F3-B05A71F88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9863F0-CB12-4274-8200-F9717060D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2E6464-4057-4AA3-93FA-9AE644695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745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E0AC9A-049B-4D07-9D6F-0734A84E6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EDD6E8-6B86-457A-87FA-BF6A4B31BD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EFA258-773E-4563-9335-7C4E54EE84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C07599-88AC-42F2-BA1F-9807BDB9D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9A6195-627D-4A36-9796-4E0955FB2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5E8C88-F05C-4569-B47E-82E8E3479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178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AA02D-7F9B-4F5C-870B-AFFFCEA19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D30DEF-E27D-443A-A6FA-CF8613DF4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DBA8A6-137A-44E7-A649-32054375B3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ACD7EA-09B6-493B-97C6-03EA227098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B0AA02-9E6D-4D57-8D46-2CDBC2D427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4857CB-125C-4067-95FA-8D6E1BE51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F04D66D-2F9B-4B1B-8D3C-EB61E5440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FE497C-3440-4CD5-BF9D-351926BC4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903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FDD7EA-CFAF-44F4-8B7B-B2E4025CEE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648ECF-053B-46EE-B2E2-250874B67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E81611-7685-4E0F-8E4A-90F3C5B78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C3F902-8E4D-46FC-9268-18B6F9EE8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188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AC846C-EC08-4540-B445-2989D4558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FE2F0DF-1822-43E5-9869-50498C22C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D8B037-BF5F-4CE9-A667-952ED6BC4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488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FEA4CC-895E-4CA3-B1F6-D46DACD45A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AE1048-CCDB-4C66-9ABE-0693A0EF1B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FF78E3-6079-4684-88CF-63EE08D25F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67018A-DBB2-4506-A552-3FDF5C432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CECC9C-D3BE-4D12-9C8E-049A56651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98E14A-666F-47ED-B8C5-7A533A727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41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DBB2D-F214-4876-9825-91A5355FB1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8641D1-D33F-4A4D-AF6F-90833D9293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3D395A-535E-47DB-8227-D2CEFFE59F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89FC3E-66B0-4D2C-B62E-4BD3BCDBA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A885FA-820F-4DCD-8FDA-B235C0F7B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94785B-A34A-4398-9600-DC9A8FBD3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71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626E10-D6ED-4F22-A107-9B76763E9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3B0D92-6B71-4A64-A885-6384BB651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DA8F0F-B5EF-495F-A54B-13D7C294BF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2BE09-6DE4-4DDE-99BC-789C7E299631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3BF2D1-85D5-4E30-B3CD-DF9970608A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C25578-EA1F-488D-898D-4C5884D29C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2C38F-7DBD-4EBF-BFF4-93BB2DD1C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335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F83F532-57DC-A2BC-0EA1-943C2FC4FF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979" y="39920"/>
            <a:ext cx="5256669" cy="4766894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08B127C6-B61A-A5DD-F1E1-A48CC7874A84}"/>
              </a:ext>
            </a:extLst>
          </p:cNvPr>
          <p:cNvSpPr/>
          <p:nvPr/>
        </p:nvSpPr>
        <p:spPr>
          <a:xfrm>
            <a:off x="304681" y="271284"/>
            <a:ext cx="5173663" cy="437691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73E568-0121-B58B-D12D-45C3214FB8F9}"/>
              </a:ext>
            </a:extLst>
          </p:cNvPr>
          <p:cNvSpPr txBox="1"/>
          <p:nvPr/>
        </p:nvSpPr>
        <p:spPr>
          <a:xfrm>
            <a:off x="304681" y="271283"/>
            <a:ext cx="437232" cy="336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endParaRPr lang="en-US" sz="1800" b="0" i="0" dirty="0">
              <a:solidFill>
                <a:srgbClr val="000000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9700432-FD72-9C96-05C9-03A28E82100B}"/>
              </a:ext>
            </a:extLst>
          </p:cNvPr>
          <p:cNvSpPr txBox="1"/>
          <p:nvPr/>
        </p:nvSpPr>
        <p:spPr>
          <a:xfrm>
            <a:off x="304681" y="2410667"/>
            <a:ext cx="437232" cy="336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endParaRPr lang="en-US" sz="1800" b="0" i="0" dirty="0">
              <a:solidFill>
                <a:srgbClr val="000000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2EFF516-47B7-759D-8C42-24EF88BACCEA}"/>
              </a:ext>
            </a:extLst>
          </p:cNvPr>
          <p:cNvSpPr txBox="1"/>
          <p:nvPr/>
        </p:nvSpPr>
        <p:spPr>
          <a:xfrm>
            <a:off x="2781087" y="271283"/>
            <a:ext cx="437232" cy="336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endParaRPr lang="en-US" sz="1800" b="0" i="0" dirty="0">
              <a:solidFill>
                <a:srgbClr val="000000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970F8AC-5321-64A2-2C91-7418333E9397}"/>
              </a:ext>
            </a:extLst>
          </p:cNvPr>
          <p:cNvSpPr txBox="1"/>
          <p:nvPr/>
        </p:nvSpPr>
        <p:spPr>
          <a:xfrm>
            <a:off x="2781087" y="2410667"/>
            <a:ext cx="437232" cy="336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endParaRPr lang="en-US" sz="1800" b="0" i="0" dirty="0">
              <a:solidFill>
                <a:srgbClr val="000000"/>
              </a:solidFill>
              <a:effectLst/>
              <a:latin typeface="Cambria" panose="020405030504060302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DAE74F4-0DEA-8ADD-FE19-55B9F7F34222}"/>
              </a:ext>
            </a:extLst>
          </p:cNvPr>
          <p:cNvSpPr/>
          <p:nvPr/>
        </p:nvSpPr>
        <p:spPr>
          <a:xfrm>
            <a:off x="304679" y="271282"/>
            <a:ext cx="5173663" cy="213938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782C5316-9227-E656-6D15-DB7DD2D4CB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187" y="2913185"/>
            <a:ext cx="228789" cy="1054316"/>
          </a:xfrm>
          <a:prstGeom prst="rect">
            <a:avLst/>
          </a:prstGeom>
        </p:spPr>
      </p:pic>
      <p:sp>
        <p:nvSpPr>
          <p:cNvPr id="3" name="Text Box 105423329">
            <a:extLst>
              <a:ext uri="{FF2B5EF4-FFF2-40B4-BE49-F238E27FC236}">
                <a16:creationId xmlns:a16="http://schemas.microsoft.com/office/drawing/2014/main" id="{6086FA55-D388-8813-FCB8-045648EEA27A}"/>
              </a:ext>
            </a:extLst>
          </p:cNvPr>
          <p:cNvSpPr txBox="1"/>
          <p:nvPr/>
        </p:nvSpPr>
        <p:spPr>
          <a:xfrm>
            <a:off x="6550973" y="271282"/>
            <a:ext cx="3677084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Liquid plug characterization and viscosity effects A)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ibration curve of air flow rate vs. measured pressure drop confirms functionality of the pressure transducer.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)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ypical pressure vs. time profile for a single liquid plug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)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distribution of times between plug initiation for 297 plugs generated sequentially under identical conditions.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)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distribution of peak pressure differentials for 297 plugs generated under identical conditions. 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0700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81579AC-EA33-5BCB-DB36-07BF3547414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195"/>
          <a:stretch/>
        </p:blipFill>
        <p:spPr>
          <a:xfrm>
            <a:off x="556643" y="1092467"/>
            <a:ext cx="8476668" cy="10421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1F7A8CE-4CD1-0B0D-EE82-7988A96357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557"/>
          <a:stretch/>
        </p:blipFill>
        <p:spPr>
          <a:xfrm>
            <a:off x="556643" y="2676492"/>
            <a:ext cx="9351770" cy="21498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EEEA1D9-2D0D-8F2C-08DE-C3A5BFE8B4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6643" y="5113142"/>
            <a:ext cx="6531288" cy="1329276"/>
          </a:xfrm>
          <a:prstGeom prst="rect">
            <a:avLst/>
          </a:prstGeom>
        </p:spPr>
      </p:pic>
      <p:sp>
        <p:nvSpPr>
          <p:cNvPr id="7" name="Text Box 105423329">
            <a:extLst>
              <a:ext uri="{FF2B5EF4-FFF2-40B4-BE49-F238E27FC236}">
                <a16:creationId xmlns:a16="http://schemas.microsoft.com/office/drawing/2014/main" id="{C07ED473-C93D-EC9B-8C05-F8BE795ED3B1}"/>
              </a:ext>
            </a:extLst>
          </p:cNvPr>
          <p:cNvSpPr txBox="1"/>
          <p:nvPr/>
        </p:nvSpPr>
        <p:spPr>
          <a:xfrm>
            <a:off x="10210799" y="1482715"/>
            <a:ext cx="157935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Eq. 1</a:t>
            </a:r>
            <a:endParaRPr lang="en-US" sz="3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 Box 105423329">
            <a:extLst>
              <a:ext uri="{FF2B5EF4-FFF2-40B4-BE49-F238E27FC236}">
                <a16:creationId xmlns:a16="http://schemas.microsoft.com/office/drawing/2014/main" id="{9DCF188E-9BCD-DA8E-6B63-4A7C5F89CDFB}"/>
              </a:ext>
            </a:extLst>
          </p:cNvPr>
          <p:cNvSpPr txBox="1"/>
          <p:nvPr/>
        </p:nvSpPr>
        <p:spPr>
          <a:xfrm>
            <a:off x="10210798" y="3136612"/>
            <a:ext cx="157935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Eq. 2</a:t>
            </a:r>
            <a:endParaRPr lang="en-US" sz="3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 Box 105423329">
            <a:extLst>
              <a:ext uri="{FF2B5EF4-FFF2-40B4-BE49-F238E27FC236}">
                <a16:creationId xmlns:a16="http://schemas.microsoft.com/office/drawing/2014/main" id="{73633BD1-2B7A-86AD-082C-84BAC1270D9C}"/>
              </a:ext>
            </a:extLst>
          </p:cNvPr>
          <p:cNvSpPr txBox="1"/>
          <p:nvPr/>
        </p:nvSpPr>
        <p:spPr>
          <a:xfrm>
            <a:off x="10215489" y="5384121"/>
            <a:ext cx="157935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6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Eq. 3</a:t>
            </a:r>
            <a:endParaRPr lang="en-US" sz="3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805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3</TotalTime>
  <Words>97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h Viola</dc:creator>
  <cp:lastModifiedBy>Hannah Viola</cp:lastModifiedBy>
  <cp:revision>3</cp:revision>
  <dcterms:created xsi:type="dcterms:W3CDTF">2021-06-13T16:39:25Z</dcterms:created>
  <dcterms:modified xsi:type="dcterms:W3CDTF">2023-05-19T15:27:09Z</dcterms:modified>
</cp:coreProperties>
</file>